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67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BD5330-0A9F-A0EF-0FDD-018953D4692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76A79A8-0315-A223-F752-43CBE81D805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9DEDF8-DDF7-C166-2342-BC86EC4800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75CE2-ADC9-410E-BD42-2A60EAD5EA9C}" type="datetimeFigureOut">
              <a:rPr lang="en-IN" smtClean="0"/>
              <a:t>24-07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50DA8A-DAE2-F1DC-022D-F2E22C7C45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3DECD6-163D-6EEE-F3C0-0712E8AE1A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39C9A6-AE0A-4D5A-B6AD-910568F02EE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257025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B6C357-69EE-D7C0-E4D8-54FA266026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7390D33-C027-88ED-2DA4-D452FD7CA21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E3D8E3-1B9B-B184-F03F-1D446FD187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75CE2-ADC9-410E-BD42-2A60EAD5EA9C}" type="datetimeFigureOut">
              <a:rPr lang="en-IN" smtClean="0"/>
              <a:t>24-07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72D457-144C-1018-4FBF-279834FF74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42C787-177C-4B3D-C51A-4268D90332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39C9A6-AE0A-4D5A-B6AD-910568F02EE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789324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063DC4D-FB76-F1A4-45C9-273BF5A6B64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32A348D-6577-79A0-E28F-923C2DE57E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06637A-2550-2B3B-FA04-9883FD12B6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75CE2-ADC9-410E-BD42-2A60EAD5EA9C}" type="datetimeFigureOut">
              <a:rPr lang="en-IN" smtClean="0"/>
              <a:t>24-07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4930B4-DBC9-70A8-31F8-9585799A5D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DAF08D-44C7-B0FC-AD60-6D7CCB09A6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39C9A6-AE0A-4D5A-B6AD-910568F02EE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909305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24B63F-8648-F57A-49FB-D056668E75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055E5E9-8F10-EE8D-53F8-818C6B7F59F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E47FDC-6546-0EE1-06C7-35339DF863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75CE2-ADC9-410E-BD42-2A60EAD5EA9C}" type="datetimeFigureOut">
              <a:rPr lang="en-IN" smtClean="0"/>
              <a:t>24-07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B93D93-6AF4-9FE8-45F2-FC7CC74493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901379-3E7A-AC78-AD90-24338DB590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39C9A6-AE0A-4D5A-B6AD-910568F02EE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86852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82A266-379E-3934-DED7-77BACE2095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672A578-3B6F-0585-3B75-CC6145BDE4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11A441-DAB6-CF6B-CCB4-F3500EBE12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75CE2-ADC9-410E-BD42-2A60EAD5EA9C}" type="datetimeFigureOut">
              <a:rPr lang="en-IN" smtClean="0"/>
              <a:t>24-07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EF396B-1605-412B-3259-308F260F37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89FA76-78AA-BA79-F81D-B1BF814572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39C9A6-AE0A-4D5A-B6AD-910568F02EE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432542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F49F38-1DB3-0796-72DC-B9DEDBB736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C1F635E-CDF4-ABF4-45A7-FF20EC4A977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E5ADF32-DB80-C788-2EE8-DCC84A1B853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A900F96-5123-2A87-BCD6-F1F0A94194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75CE2-ADC9-410E-BD42-2A60EAD5EA9C}" type="datetimeFigureOut">
              <a:rPr lang="en-IN" smtClean="0"/>
              <a:t>24-07-2023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3F93EE2-13A0-17CF-DBB7-B7B853D823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41618C7-2B44-1ECF-11D9-9D71C53D1C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39C9A6-AE0A-4D5A-B6AD-910568F02EE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915514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176FA0-E69A-2177-9F6B-E3C5A1FDEA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2D9EE68-F2A5-DAD3-8183-D984B75EF6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3DD76C3-A173-6184-B754-05249781ACA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408F590-2476-EE09-10A3-2D71B340AEF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EFBA149-1E11-57FE-1D30-63DDD23E5E1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3BD0E88-8C3C-4EB4-0545-6DD8CA3760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75CE2-ADC9-410E-BD42-2A60EAD5EA9C}" type="datetimeFigureOut">
              <a:rPr lang="en-IN" smtClean="0"/>
              <a:t>24-07-2023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2F20505-5E6A-21B6-E481-575328C21F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1D125F6-DE6D-2488-0F33-9A30A19042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39C9A6-AE0A-4D5A-B6AD-910568F02EE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18150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E1F5DA-6984-9F36-2229-625BD3569B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F27FCE1-065D-324C-D313-B73F695971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75CE2-ADC9-410E-BD42-2A60EAD5EA9C}" type="datetimeFigureOut">
              <a:rPr lang="en-IN" smtClean="0"/>
              <a:t>24-07-2023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29C32B3-F67E-ED13-4322-0DD8DBA52A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209B819-B833-45F0-17FE-1E9B2A6976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39C9A6-AE0A-4D5A-B6AD-910568F02EE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864171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8C1C1F2-A4E1-B00C-39E6-ED0CE28612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75CE2-ADC9-410E-BD42-2A60EAD5EA9C}" type="datetimeFigureOut">
              <a:rPr lang="en-IN" smtClean="0"/>
              <a:t>24-07-2023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0919756-270D-49D9-4AAD-55AD8061D8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C825017-32C7-5D69-23F6-4C8306E74B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39C9A6-AE0A-4D5A-B6AD-910568F02EE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767510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C0364E-5F9F-0D83-775C-811873BBEA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9BC0ED2-20B0-90C7-C1D3-0FCC736ECD6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F2C2DC4-4843-30B6-108E-65A9C62A406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90B8B54-E089-0259-1573-9728B7946B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75CE2-ADC9-410E-BD42-2A60EAD5EA9C}" type="datetimeFigureOut">
              <a:rPr lang="en-IN" smtClean="0"/>
              <a:t>24-07-2023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49BFAB2-C409-956E-2DCF-D1AB77201C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E415BA6-744B-5982-B6AC-9E0DDF6C89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39C9A6-AE0A-4D5A-B6AD-910568F02EE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53531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4AD507-BBFD-8FD2-2F02-072ADFCDE2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8918CF5-B3B2-C0D1-3BF3-5B448344B80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E332D3D-F38C-FF3C-D2A2-D464BD844D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EF03E97-B992-9031-6711-B240560626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75CE2-ADC9-410E-BD42-2A60EAD5EA9C}" type="datetimeFigureOut">
              <a:rPr lang="en-IN" smtClean="0"/>
              <a:t>24-07-2023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E4EEDE0-C4B3-9E71-101B-689211118E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B05BA5A-3050-8601-EB76-8189C18975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39C9A6-AE0A-4D5A-B6AD-910568F02EE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512949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8A4FA59-C970-094A-1D69-93D043E1DF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1369F5A-1055-A2C2-A088-BFABD2A015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29FDF4-4E8B-EDBE-0082-AC8772B8E9D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275CE2-ADC9-410E-BD42-2A60EAD5EA9C}" type="datetimeFigureOut">
              <a:rPr lang="en-IN" smtClean="0"/>
              <a:t>24-07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99A67A-7276-0514-1A86-3B9C9A07DA0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A2C565-9429-0134-1F16-09E0184D343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39C9A6-AE0A-4D5A-B6AD-910568F02EE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694448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68E5F63B-568D-BEE6-F6F9-1DC7477C981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0111" y="828136"/>
            <a:ext cx="6222413" cy="3761861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396363CB-A3DB-F187-5184-AF8C447C87C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12524" y="828135"/>
            <a:ext cx="4622316" cy="3761862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EB99694B-92B9-BEF3-B3C7-DBE863ED6646}"/>
              </a:ext>
            </a:extLst>
          </p:cNvPr>
          <p:cNvSpPr txBox="1"/>
          <p:nvPr/>
        </p:nvSpPr>
        <p:spPr>
          <a:xfrm>
            <a:off x="690111" y="4727275"/>
            <a:ext cx="1084472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165225" indent="-1165225" algn="just"/>
            <a:r>
              <a:rPr lang="en-IN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r>
              <a:rPr lang="en-IN" dirty="0">
                <a:latin typeface="Arial" panose="020B0604020202020204" pitchFamily="34" charset="0"/>
                <a:cs typeface="Arial" panose="020B0604020202020204" pitchFamily="34" charset="0"/>
              </a:rPr>
              <a:t>: Radar plot showing the physicochemical properties of the selected compounds against </a:t>
            </a:r>
            <a:r>
              <a:rPr lang="en-IN" dirty="0" err="1">
                <a:latin typeface="Arial" panose="020B0604020202020204" pitchFamily="34" charset="0"/>
                <a:cs typeface="Arial" panose="020B0604020202020204" pitchFamily="34" charset="0"/>
              </a:rPr>
              <a:t>FtsZ</a:t>
            </a:r>
            <a:r>
              <a:rPr lang="en-IN" dirty="0">
                <a:latin typeface="Arial" panose="020B0604020202020204" pitchFamily="34" charset="0"/>
                <a:cs typeface="Arial" panose="020B0604020202020204" pitchFamily="34" charset="0"/>
              </a:rPr>
              <a:t> calculated through </a:t>
            </a:r>
            <a:r>
              <a:rPr lang="en-IN" dirty="0" err="1">
                <a:latin typeface="Arial" panose="020B0604020202020204" pitchFamily="34" charset="0"/>
                <a:cs typeface="Arial" panose="020B0604020202020204" pitchFamily="34" charset="0"/>
              </a:rPr>
              <a:t>SwissADME</a:t>
            </a:r>
            <a:r>
              <a:rPr lang="en-IN" dirty="0">
                <a:latin typeface="Arial" panose="020B0604020202020204" pitchFamily="34" charset="0"/>
                <a:cs typeface="Arial" panose="020B0604020202020204" pitchFamily="34" charset="0"/>
              </a:rPr>
              <a:t> server (http://www.swissadme.ch/index.php).</a:t>
            </a:r>
          </a:p>
        </p:txBody>
      </p:sp>
    </p:spTree>
    <p:extLst>
      <p:ext uri="{BB962C8B-B14F-4D97-AF65-F5344CB8AC3E}">
        <p14:creationId xmlns:p14="http://schemas.microsoft.com/office/powerpoint/2010/main" val="22766431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7</TotalTime>
  <Words>32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j Mohammad</dc:creator>
  <cp:lastModifiedBy>Taj Mohammad</cp:lastModifiedBy>
  <cp:revision>2</cp:revision>
  <dcterms:created xsi:type="dcterms:W3CDTF">2023-07-24T10:42:07Z</dcterms:created>
  <dcterms:modified xsi:type="dcterms:W3CDTF">2023-07-24T11:39:10Z</dcterms:modified>
</cp:coreProperties>
</file>